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1357AD-F7CC-447F-88E2-25C0A70CF0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20121D-E94E-4ADD-8B41-68FA3E9109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05E4A5-AAFD-4A73-8CE6-F8896D531AE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9A9885-F6B8-44BD-B64E-E6AA3030349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F660BD-43C1-40F3-A919-FB2BB3A22F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72814D-C1E8-422A-8B90-9FC16BB52C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EAB7BB-DBE9-4F68-A9FA-30F0865A18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DA723B-1E2F-4728-8D72-4FF5C0B407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828487-868B-4321-8E7A-41C9464CD3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18CC12-69A0-4D75-A17D-8DBEFA3D26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9DF363-7F32-415F-AD05-289F63E123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59A4DD-D133-4FD1-B5ED-6CAFE279A7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659DB41-DB45-4B82-ADD9-98CE35205BF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feld 59"/>
          <p:cNvSpPr/>
          <p:nvPr/>
        </p:nvSpPr>
        <p:spPr>
          <a:xfrm>
            <a:off x="4987800" y="2435400"/>
            <a:ext cx="32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7f7f7f"/>
                </a:solidFill>
                <a:latin typeface="Calibri"/>
              </a:rPr>
              <a:t>AT2G211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Gerade Verbindung 118"/>
          <p:cNvSpPr/>
          <p:nvPr/>
        </p:nvSpPr>
        <p:spPr>
          <a:xfrm flipH="1" flipV="1">
            <a:off x="3563640" y="1793520"/>
            <a:ext cx="96840" cy="167796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Gerade Verbindung 101"/>
          <p:cNvSpPr/>
          <p:nvPr/>
        </p:nvSpPr>
        <p:spPr>
          <a:xfrm flipV="1">
            <a:off x="3076560" y="1757160"/>
            <a:ext cx="395280" cy="133812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Gerade Verbindung 92"/>
          <p:cNvSpPr/>
          <p:nvPr/>
        </p:nvSpPr>
        <p:spPr>
          <a:xfrm flipH="1" flipV="1">
            <a:off x="3654000" y="1757160"/>
            <a:ext cx="1112760" cy="128268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Gerade Verbindung 64"/>
          <p:cNvSpPr/>
          <p:nvPr/>
        </p:nvSpPr>
        <p:spPr>
          <a:xfrm flipV="1">
            <a:off x="2262240" y="1665000"/>
            <a:ext cx="1171440" cy="29052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Ellipse 5"/>
          <p:cNvSpPr/>
          <p:nvPr/>
        </p:nvSpPr>
        <p:spPr>
          <a:xfrm>
            <a:off x="3433680" y="1125360"/>
            <a:ext cx="258840" cy="25884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feld 6"/>
          <p:cNvSpPr/>
          <p:nvPr/>
        </p:nvSpPr>
        <p:spPr>
          <a:xfrm>
            <a:off x="3327480" y="1114560"/>
            <a:ext cx="71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tHb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Ellipse 7"/>
          <p:cNvSpPr/>
          <p:nvPr/>
        </p:nvSpPr>
        <p:spPr>
          <a:xfrm>
            <a:off x="3433680" y="1535040"/>
            <a:ext cx="258840" cy="258840"/>
          </a:xfrm>
          <a:prstGeom prst="ellipse">
            <a:avLst/>
          </a:prstGeom>
          <a:gradFill rotWithShape="0">
            <a:gsLst>
              <a:gs pos="0">
                <a:srgbClr val="ffa2a1"/>
              </a:gs>
              <a:gs pos="100000">
                <a:srgbClr val="ffe5e5"/>
              </a:gs>
            </a:gsLst>
            <a:lin ang="16200000"/>
          </a:gradFill>
          <a:ln w="9360">
            <a:solidFill>
              <a:srgbClr val="be4b48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Gerade Verbindung 9"/>
          <p:cNvSpPr/>
          <p:nvPr/>
        </p:nvSpPr>
        <p:spPr>
          <a:xfrm>
            <a:off x="3564000" y="1384200"/>
            <a:ext cx="0" cy="150840"/>
          </a:xfrm>
          <a:prstGeom prst="line">
            <a:avLst/>
          </a:prstGeom>
          <a:ln w="9360">
            <a:solidFill>
              <a:srgbClr val="f692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Ellipse 11"/>
          <p:cNvSpPr/>
          <p:nvPr/>
        </p:nvSpPr>
        <p:spPr>
          <a:xfrm>
            <a:off x="2041560" y="1917720"/>
            <a:ext cx="258840" cy="25884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feld 12"/>
          <p:cNvSpPr/>
          <p:nvPr/>
        </p:nvSpPr>
        <p:spPr>
          <a:xfrm>
            <a:off x="1527120" y="1835280"/>
            <a:ext cx="1297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</a:rPr>
              <a:t>S-adenosyl-L-methionine:carboxyl methyltransferase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Ellipse 13"/>
          <p:cNvSpPr/>
          <p:nvPr/>
        </p:nvSpPr>
        <p:spPr>
          <a:xfrm>
            <a:off x="2495520" y="2251080"/>
            <a:ext cx="258840" cy="25884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feld 14"/>
          <p:cNvSpPr/>
          <p:nvPr/>
        </p:nvSpPr>
        <p:spPr>
          <a:xfrm>
            <a:off x="2274840" y="2235240"/>
            <a:ext cx="692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LEA group1 prote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Ellipse 17"/>
          <p:cNvSpPr/>
          <p:nvPr/>
        </p:nvSpPr>
        <p:spPr>
          <a:xfrm>
            <a:off x="2946240" y="3095640"/>
            <a:ext cx="258840" cy="25884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feld 18"/>
          <p:cNvSpPr/>
          <p:nvPr/>
        </p:nvSpPr>
        <p:spPr>
          <a:xfrm>
            <a:off x="2697120" y="3097080"/>
            <a:ext cx="1068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LEA protein 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Ellipse 19"/>
          <p:cNvSpPr/>
          <p:nvPr/>
        </p:nvSpPr>
        <p:spPr>
          <a:xfrm>
            <a:off x="2786040" y="2630520"/>
            <a:ext cx="258840" cy="258840"/>
          </a:xfrm>
          <a:prstGeom prst="ellipse">
            <a:avLst/>
          </a:prstGeom>
          <a:gradFill rotWithShape="0">
            <a:gsLst>
              <a:gs pos="0">
                <a:srgbClr val="ffa2a1"/>
              </a:gs>
              <a:gs pos="100000">
                <a:srgbClr val="ffe5e5"/>
              </a:gs>
            </a:gsLst>
            <a:lin ang="16200000"/>
          </a:gradFill>
          <a:ln w="9360">
            <a:solidFill>
              <a:srgbClr val="be4b48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feld 20"/>
          <p:cNvSpPr/>
          <p:nvPr/>
        </p:nvSpPr>
        <p:spPr>
          <a:xfrm>
            <a:off x="2030400" y="2554200"/>
            <a:ext cx="1513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xyloglucan:xyloglucosyl transferase B / XTR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Ellipse 21"/>
          <p:cNvSpPr/>
          <p:nvPr/>
        </p:nvSpPr>
        <p:spPr>
          <a:xfrm>
            <a:off x="2041560" y="3276720"/>
            <a:ext cx="258840" cy="260280"/>
          </a:xfrm>
          <a:prstGeom prst="ellipse">
            <a:avLst/>
          </a:prstGeom>
          <a:gradFill rotWithShape="0">
            <a:gsLst>
              <a:gs pos="0">
                <a:srgbClr val="ffa2a1"/>
              </a:gs>
              <a:gs pos="100000">
                <a:srgbClr val="ffe5e5"/>
              </a:gs>
            </a:gsLst>
            <a:lin ang="16200000"/>
          </a:gradFill>
          <a:ln w="9360">
            <a:solidFill>
              <a:srgbClr val="be4b48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feld 22"/>
          <p:cNvSpPr/>
          <p:nvPr/>
        </p:nvSpPr>
        <p:spPr>
          <a:xfrm>
            <a:off x="1527120" y="3203640"/>
            <a:ext cx="1224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xyloglucan:xyloglucosyl transferase 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Ellipse 23"/>
          <p:cNvSpPr/>
          <p:nvPr/>
        </p:nvSpPr>
        <p:spPr>
          <a:xfrm>
            <a:off x="2462040" y="3602160"/>
            <a:ext cx="260640" cy="258480"/>
          </a:xfrm>
          <a:prstGeom prst="ellipse">
            <a:avLst/>
          </a:prstGeom>
          <a:gradFill rotWithShape="0">
            <a:gsLst>
              <a:gs pos="0">
                <a:srgbClr val="ffa2a1"/>
              </a:gs>
              <a:gs pos="100000">
                <a:srgbClr val="ffe5e5"/>
              </a:gs>
            </a:gsLst>
            <a:lin ang="16200000"/>
          </a:gradFill>
          <a:ln w="9360">
            <a:solidFill>
              <a:srgbClr val="be4b48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feld 24"/>
          <p:cNvSpPr/>
          <p:nvPr/>
        </p:nvSpPr>
        <p:spPr>
          <a:xfrm>
            <a:off x="2068560" y="3571920"/>
            <a:ext cx="1092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auxin-responsive prote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Ellipse 25"/>
          <p:cNvSpPr/>
          <p:nvPr/>
        </p:nvSpPr>
        <p:spPr>
          <a:xfrm>
            <a:off x="3240000" y="2597040"/>
            <a:ext cx="258840" cy="260640"/>
          </a:xfrm>
          <a:prstGeom prst="ellipse">
            <a:avLst/>
          </a:prstGeom>
          <a:gradFill rotWithShape="0">
            <a:gsLst>
              <a:gs pos="0">
                <a:srgbClr val="ffa2a1"/>
              </a:gs>
              <a:gs pos="100000">
                <a:srgbClr val="ffe5e5"/>
              </a:gs>
            </a:gsLst>
            <a:lin ang="16200000"/>
          </a:gradFill>
          <a:ln w="9360">
            <a:solidFill>
              <a:srgbClr val="be4b48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Ellipse 36"/>
          <p:cNvSpPr/>
          <p:nvPr/>
        </p:nvSpPr>
        <p:spPr>
          <a:xfrm>
            <a:off x="4729320" y="3000240"/>
            <a:ext cx="258480" cy="26064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feld 37"/>
          <p:cNvSpPr/>
          <p:nvPr/>
        </p:nvSpPr>
        <p:spPr>
          <a:xfrm>
            <a:off x="4335480" y="2987640"/>
            <a:ext cx="1068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oxidoreduct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Ellipse 39"/>
          <p:cNvSpPr/>
          <p:nvPr/>
        </p:nvSpPr>
        <p:spPr>
          <a:xfrm>
            <a:off x="3692520" y="2305080"/>
            <a:ext cx="258840" cy="26028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Ellipse 42"/>
          <p:cNvSpPr/>
          <p:nvPr/>
        </p:nvSpPr>
        <p:spPr>
          <a:xfrm>
            <a:off x="3530520" y="3471840"/>
            <a:ext cx="258840" cy="258840"/>
          </a:xfrm>
          <a:prstGeom prst="ellipse">
            <a:avLst/>
          </a:prstGeom>
          <a:gradFill rotWithShape="0">
            <a:gsLst>
              <a:gs pos="0">
                <a:srgbClr val="ffa2a1"/>
              </a:gs>
              <a:gs pos="100000">
                <a:srgbClr val="ffe5e5"/>
              </a:gs>
            </a:gsLst>
            <a:lin ang="16200000"/>
          </a:gradFill>
          <a:ln w="9360">
            <a:solidFill>
              <a:srgbClr val="be4b48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feld 43"/>
          <p:cNvSpPr/>
          <p:nvPr/>
        </p:nvSpPr>
        <p:spPr>
          <a:xfrm>
            <a:off x="3111480" y="3490920"/>
            <a:ext cx="110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acid phosphatase class 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Ellipse 45"/>
          <p:cNvSpPr/>
          <p:nvPr/>
        </p:nvSpPr>
        <p:spPr>
          <a:xfrm>
            <a:off x="3595680" y="2693880"/>
            <a:ext cx="258840" cy="26028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feld 46"/>
          <p:cNvSpPr/>
          <p:nvPr/>
        </p:nvSpPr>
        <p:spPr>
          <a:xfrm>
            <a:off x="3543480" y="2698920"/>
            <a:ext cx="849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PAD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Ellipse 48"/>
          <p:cNvSpPr/>
          <p:nvPr/>
        </p:nvSpPr>
        <p:spPr>
          <a:xfrm>
            <a:off x="5035680" y="1835280"/>
            <a:ext cx="260280" cy="25848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feld 49"/>
          <p:cNvSpPr/>
          <p:nvPr/>
        </p:nvSpPr>
        <p:spPr>
          <a:xfrm>
            <a:off x="4703760" y="1847880"/>
            <a:ext cx="103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</a:rPr>
              <a:t>LEA protein_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Ellipse 51"/>
          <p:cNvSpPr/>
          <p:nvPr/>
        </p:nvSpPr>
        <p:spPr>
          <a:xfrm>
            <a:off x="4761000" y="2158920"/>
            <a:ext cx="258840" cy="25884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feld 52"/>
          <p:cNvSpPr/>
          <p:nvPr/>
        </p:nvSpPr>
        <p:spPr>
          <a:xfrm>
            <a:off x="4695840" y="2195640"/>
            <a:ext cx="838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XTR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Ellipse 54"/>
          <p:cNvSpPr/>
          <p:nvPr/>
        </p:nvSpPr>
        <p:spPr>
          <a:xfrm>
            <a:off x="4664160" y="2590920"/>
            <a:ext cx="258840" cy="25848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feld 55"/>
          <p:cNvSpPr/>
          <p:nvPr/>
        </p:nvSpPr>
        <p:spPr>
          <a:xfrm>
            <a:off x="4551480" y="2627280"/>
            <a:ext cx="89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GASA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Ellipse 57"/>
          <p:cNvSpPr/>
          <p:nvPr/>
        </p:nvSpPr>
        <p:spPr>
          <a:xfrm>
            <a:off x="5019840" y="2506680"/>
            <a:ext cx="260280" cy="258840"/>
          </a:xfrm>
          <a:prstGeom prst="ellipse">
            <a:avLst/>
          </a:prstGeom>
          <a:gradFill rotWithShape="0">
            <a:gsLst>
              <a:gs pos="0">
                <a:srgbClr val="ffa2a1"/>
              </a:gs>
              <a:gs pos="100000">
                <a:srgbClr val="ffe5e5"/>
              </a:gs>
            </a:gsLst>
            <a:lin ang="16200000"/>
          </a:gradFill>
          <a:ln w="9360">
            <a:solidFill>
              <a:srgbClr val="be4b48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feld 58"/>
          <p:cNvSpPr/>
          <p:nvPr/>
        </p:nvSpPr>
        <p:spPr>
          <a:xfrm>
            <a:off x="4911840" y="2482920"/>
            <a:ext cx="780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TPRP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Gerade Verbindung 68"/>
          <p:cNvSpPr/>
          <p:nvPr/>
        </p:nvSpPr>
        <p:spPr>
          <a:xfrm flipV="1">
            <a:off x="2715480" y="1757160"/>
            <a:ext cx="755640" cy="53172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Gerade Verbindung 71"/>
          <p:cNvSpPr/>
          <p:nvPr/>
        </p:nvSpPr>
        <p:spPr>
          <a:xfrm flipH="1" flipV="1">
            <a:off x="3692160" y="1665000"/>
            <a:ext cx="1382760" cy="20772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Gerade Verbindung 74"/>
          <p:cNvSpPr/>
          <p:nvPr/>
        </p:nvSpPr>
        <p:spPr>
          <a:xfrm flipV="1">
            <a:off x="2979720" y="1787400"/>
            <a:ext cx="487440" cy="87480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Gerade Verbindung 77"/>
          <p:cNvSpPr/>
          <p:nvPr/>
        </p:nvSpPr>
        <p:spPr>
          <a:xfrm flipV="1">
            <a:off x="3367800" y="1793520"/>
            <a:ext cx="195480" cy="80316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Gerade Verbindung 81"/>
          <p:cNvSpPr/>
          <p:nvPr/>
        </p:nvSpPr>
        <p:spPr>
          <a:xfrm flipH="1" flipV="1">
            <a:off x="3563640" y="1793880"/>
            <a:ext cx="258840" cy="51120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Gerade Verbindung 86"/>
          <p:cNvSpPr/>
          <p:nvPr/>
        </p:nvSpPr>
        <p:spPr>
          <a:xfrm flipH="1" flipV="1">
            <a:off x="3654360" y="1757160"/>
            <a:ext cx="1144800" cy="43956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Gerade Verbindung 89"/>
          <p:cNvSpPr/>
          <p:nvPr/>
        </p:nvSpPr>
        <p:spPr>
          <a:xfrm flipH="1" flipV="1">
            <a:off x="3654000" y="1757160"/>
            <a:ext cx="1047960" cy="87156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Gerade Verbindung 95"/>
          <p:cNvSpPr/>
          <p:nvPr/>
        </p:nvSpPr>
        <p:spPr>
          <a:xfrm flipH="1" flipV="1">
            <a:off x="3654000" y="1757160"/>
            <a:ext cx="1365480" cy="87948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Gerade Verbindung 106"/>
          <p:cNvSpPr/>
          <p:nvPr/>
        </p:nvSpPr>
        <p:spPr>
          <a:xfrm flipH="1" flipV="1">
            <a:off x="3564000" y="1793880"/>
            <a:ext cx="162000" cy="90000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Gerade Verbindung 112"/>
          <p:cNvSpPr/>
          <p:nvPr/>
        </p:nvSpPr>
        <p:spPr>
          <a:xfrm>
            <a:off x="2261520" y="3498840"/>
            <a:ext cx="237960" cy="13968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Gerade Verbindung 115"/>
          <p:cNvSpPr/>
          <p:nvPr/>
        </p:nvSpPr>
        <p:spPr>
          <a:xfrm flipH="1" flipV="1">
            <a:off x="3687480" y="1762200"/>
            <a:ext cx="811080" cy="194472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Gerade Verbindung 122"/>
          <p:cNvSpPr/>
          <p:nvPr/>
        </p:nvSpPr>
        <p:spPr>
          <a:xfrm>
            <a:off x="2170080" y="2176560"/>
            <a:ext cx="0" cy="110016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Gerade Verbindung 129"/>
          <p:cNvSpPr/>
          <p:nvPr/>
        </p:nvSpPr>
        <p:spPr>
          <a:xfrm>
            <a:off x="2624040" y="2509920"/>
            <a:ext cx="200160" cy="15696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Gerade Verbindung 132"/>
          <p:cNvSpPr/>
          <p:nvPr/>
        </p:nvSpPr>
        <p:spPr>
          <a:xfrm flipH="1">
            <a:off x="2261880" y="2851200"/>
            <a:ext cx="561960" cy="46368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Gerade Verbindung 134"/>
          <p:cNvSpPr/>
          <p:nvPr/>
        </p:nvSpPr>
        <p:spPr>
          <a:xfrm flipH="1">
            <a:off x="2682360" y="2889360"/>
            <a:ext cx="233640" cy="74916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Gerade Verbindung 136"/>
          <p:cNvSpPr/>
          <p:nvPr/>
        </p:nvSpPr>
        <p:spPr>
          <a:xfrm flipV="1">
            <a:off x="2300400" y="3223800"/>
            <a:ext cx="645840" cy="18252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Gerade Verbindung 137"/>
          <p:cNvSpPr/>
          <p:nvPr/>
        </p:nvSpPr>
        <p:spPr>
          <a:xfrm flipH="1" flipV="1">
            <a:off x="3205080" y="3224160"/>
            <a:ext cx="363600" cy="28584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Gerade Verbindung 141"/>
          <p:cNvSpPr/>
          <p:nvPr/>
        </p:nvSpPr>
        <p:spPr>
          <a:xfrm>
            <a:off x="2300400" y="3406680"/>
            <a:ext cx="1230120" cy="16200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Gerade Verbindung 146"/>
          <p:cNvSpPr/>
          <p:nvPr/>
        </p:nvSpPr>
        <p:spPr>
          <a:xfrm flipH="1">
            <a:off x="5149800" y="2093760"/>
            <a:ext cx="15840" cy="41292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Gerade Verbindung 150"/>
          <p:cNvSpPr/>
          <p:nvPr/>
        </p:nvSpPr>
        <p:spPr>
          <a:xfrm flipV="1">
            <a:off x="4949280" y="2765160"/>
            <a:ext cx="199800" cy="27468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Gerade Verbindung 153"/>
          <p:cNvSpPr/>
          <p:nvPr/>
        </p:nvSpPr>
        <p:spPr>
          <a:xfrm>
            <a:off x="4982400" y="2381400"/>
            <a:ext cx="74520" cy="16344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Gerade Verbindung 156"/>
          <p:cNvSpPr/>
          <p:nvPr/>
        </p:nvSpPr>
        <p:spPr>
          <a:xfrm>
            <a:off x="4923000" y="2720880"/>
            <a:ext cx="129960" cy="792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Gerade Verbindung 174"/>
          <p:cNvSpPr/>
          <p:nvPr/>
        </p:nvSpPr>
        <p:spPr>
          <a:xfrm flipV="1">
            <a:off x="3816360" y="2565000"/>
            <a:ext cx="6480" cy="16668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Gerade Verbindung 181"/>
          <p:cNvSpPr/>
          <p:nvPr/>
        </p:nvSpPr>
        <p:spPr>
          <a:xfrm flipH="1" flipV="1">
            <a:off x="2715840" y="2473200"/>
            <a:ext cx="523800" cy="25416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Gerade Verbindung 184"/>
          <p:cNvSpPr/>
          <p:nvPr/>
        </p:nvSpPr>
        <p:spPr>
          <a:xfrm flipH="1">
            <a:off x="3076560" y="2819520"/>
            <a:ext cx="201600" cy="54756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Gerade Verbindung 188"/>
          <p:cNvSpPr/>
          <p:nvPr/>
        </p:nvSpPr>
        <p:spPr>
          <a:xfrm>
            <a:off x="3368520" y="2857680"/>
            <a:ext cx="292320" cy="61416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Gerade Verbindung 191"/>
          <p:cNvSpPr/>
          <p:nvPr/>
        </p:nvSpPr>
        <p:spPr>
          <a:xfrm>
            <a:off x="3498840" y="2727360"/>
            <a:ext cx="135000" cy="468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Gerade Verbindung 196"/>
          <p:cNvSpPr/>
          <p:nvPr/>
        </p:nvSpPr>
        <p:spPr>
          <a:xfrm flipV="1">
            <a:off x="3460680" y="2435040"/>
            <a:ext cx="231840" cy="19980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Gerade Verbindung 205"/>
          <p:cNvSpPr/>
          <p:nvPr/>
        </p:nvSpPr>
        <p:spPr>
          <a:xfrm>
            <a:off x="3460680" y="2819520"/>
            <a:ext cx="1106640" cy="84744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feld 59"/>
          <p:cNvSpPr/>
          <p:nvPr/>
        </p:nvSpPr>
        <p:spPr>
          <a:xfrm>
            <a:off x="3495600" y="5384880"/>
            <a:ext cx="32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7f7f7f"/>
                </a:solidFill>
                <a:latin typeface="Calibri"/>
              </a:rPr>
              <a:t>AT2G211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Ellipse 5"/>
          <p:cNvSpPr/>
          <p:nvPr/>
        </p:nvSpPr>
        <p:spPr>
          <a:xfrm>
            <a:off x="3527280" y="4788000"/>
            <a:ext cx="258840" cy="25884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feld 6"/>
          <p:cNvSpPr/>
          <p:nvPr/>
        </p:nvSpPr>
        <p:spPr>
          <a:xfrm>
            <a:off x="3400560" y="4776840"/>
            <a:ext cx="768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tHb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Ellipse 7"/>
          <p:cNvSpPr/>
          <p:nvPr/>
        </p:nvSpPr>
        <p:spPr>
          <a:xfrm>
            <a:off x="2200320" y="5229360"/>
            <a:ext cx="258840" cy="258480"/>
          </a:xfrm>
          <a:prstGeom prst="ellipse">
            <a:avLst/>
          </a:prstGeom>
          <a:gradFill rotWithShape="0">
            <a:gsLst>
              <a:gs pos="0">
                <a:srgbClr val="ffa2a1"/>
              </a:gs>
              <a:gs pos="100000">
                <a:srgbClr val="ffe5e5"/>
              </a:gs>
            </a:gsLst>
            <a:lin ang="16200000"/>
          </a:gradFill>
          <a:ln w="9360">
            <a:solidFill>
              <a:srgbClr val="be4b48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Gerade Verbindung 9"/>
          <p:cNvSpPr/>
          <p:nvPr/>
        </p:nvSpPr>
        <p:spPr>
          <a:xfrm>
            <a:off x="3657600" y="5046840"/>
            <a:ext cx="0" cy="40932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Ellipse 11"/>
          <p:cNvSpPr/>
          <p:nvPr/>
        </p:nvSpPr>
        <p:spPr>
          <a:xfrm>
            <a:off x="1714680" y="6257880"/>
            <a:ext cx="258480" cy="25884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Ellipse 13"/>
          <p:cNvSpPr/>
          <p:nvPr/>
        </p:nvSpPr>
        <p:spPr>
          <a:xfrm>
            <a:off x="1746360" y="7192800"/>
            <a:ext cx="260280" cy="25740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feld 14"/>
          <p:cNvSpPr/>
          <p:nvPr/>
        </p:nvSpPr>
        <p:spPr>
          <a:xfrm>
            <a:off x="1504800" y="7253280"/>
            <a:ext cx="792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LEA group1 prote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Ellipse 17"/>
          <p:cNvSpPr/>
          <p:nvPr/>
        </p:nvSpPr>
        <p:spPr>
          <a:xfrm>
            <a:off x="2619360" y="7197840"/>
            <a:ext cx="258840" cy="25848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feld 18"/>
          <p:cNvSpPr/>
          <p:nvPr/>
        </p:nvSpPr>
        <p:spPr>
          <a:xfrm>
            <a:off x="2444760" y="7259760"/>
            <a:ext cx="617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LEA protein 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Ellipse 19"/>
          <p:cNvSpPr/>
          <p:nvPr/>
        </p:nvSpPr>
        <p:spPr>
          <a:xfrm>
            <a:off x="2814480" y="5421240"/>
            <a:ext cx="260640" cy="258840"/>
          </a:xfrm>
          <a:prstGeom prst="ellipse">
            <a:avLst/>
          </a:prstGeom>
          <a:gradFill rotWithShape="0">
            <a:gsLst>
              <a:gs pos="0">
                <a:srgbClr val="ffa2a1"/>
              </a:gs>
              <a:gs pos="100000">
                <a:srgbClr val="ffe5e5"/>
              </a:gs>
            </a:gsLst>
            <a:lin ang="16200000"/>
          </a:gradFill>
          <a:ln w="9360">
            <a:solidFill>
              <a:srgbClr val="be4b48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Ellipse 21"/>
          <p:cNvSpPr/>
          <p:nvPr/>
        </p:nvSpPr>
        <p:spPr>
          <a:xfrm>
            <a:off x="1714680" y="5578560"/>
            <a:ext cx="258480" cy="260280"/>
          </a:xfrm>
          <a:prstGeom prst="ellipse">
            <a:avLst/>
          </a:prstGeom>
          <a:gradFill rotWithShape="0">
            <a:gsLst>
              <a:gs pos="0">
                <a:srgbClr val="ffa2a1"/>
              </a:gs>
              <a:gs pos="100000">
                <a:srgbClr val="ffe5e5"/>
              </a:gs>
            </a:gsLst>
            <a:lin ang="16200000"/>
          </a:gradFill>
          <a:ln w="9360">
            <a:solidFill>
              <a:srgbClr val="be4b48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Ellipse 23"/>
          <p:cNvSpPr/>
          <p:nvPr/>
        </p:nvSpPr>
        <p:spPr>
          <a:xfrm>
            <a:off x="2233440" y="6620040"/>
            <a:ext cx="258840" cy="258480"/>
          </a:xfrm>
          <a:prstGeom prst="ellipse">
            <a:avLst/>
          </a:prstGeom>
          <a:gradFill rotWithShape="0">
            <a:gsLst>
              <a:gs pos="0">
                <a:srgbClr val="ffa2a1"/>
              </a:gs>
              <a:gs pos="100000">
                <a:srgbClr val="ffe5e5"/>
              </a:gs>
            </a:gsLst>
            <a:lin ang="16200000"/>
          </a:gradFill>
          <a:ln w="9360">
            <a:solidFill>
              <a:srgbClr val="be4b48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feld 24"/>
          <p:cNvSpPr/>
          <p:nvPr/>
        </p:nvSpPr>
        <p:spPr>
          <a:xfrm>
            <a:off x="1862280" y="6605640"/>
            <a:ext cx="1073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auxin-responsive prote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Ellipse 25"/>
          <p:cNvSpPr/>
          <p:nvPr/>
        </p:nvSpPr>
        <p:spPr>
          <a:xfrm>
            <a:off x="2492280" y="5715000"/>
            <a:ext cx="258840" cy="258840"/>
          </a:xfrm>
          <a:prstGeom prst="ellipse">
            <a:avLst/>
          </a:prstGeom>
          <a:gradFill rotWithShape="0">
            <a:gsLst>
              <a:gs pos="0">
                <a:srgbClr val="ffa2a1"/>
              </a:gs>
              <a:gs pos="100000">
                <a:srgbClr val="ffe5e5"/>
              </a:gs>
            </a:gsLst>
            <a:lin ang="16200000"/>
          </a:gradFill>
          <a:ln w="9360">
            <a:solidFill>
              <a:srgbClr val="be4b48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Ellipse 36"/>
          <p:cNvSpPr/>
          <p:nvPr/>
        </p:nvSpPr>
        <p:spPr>
          <a:xfrm>
            <a:off x="4660920" y="4964040"/>
            <a:ext cx="258840" cy="25884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Ellipse 39"/>
          <p:cNvSpPr/>
          <p:nvPr/>
        </p:nvSpPr>
        <p:spPr>
          <a:xfrm>
            <a:off x="4148280" y="5288040"/>
            <a:ext cx="258480" cy="25884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feld 41"/>
          <p:cNvSpPr/>
          <p:nvPr/>
        </p:nvSpPr>
        <p:spPr>
          <a:xfrm>
            <a:off x="4067280" y="5295960"/>
            <a:ext cx="714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unknown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Ellipse 42"/>
          <p:cNvSpPr/>
          <p:nvPr/>
        </p:nvSpPr>
        <p:spPr>
          <a:xfrm>
            <a:off x="4530600" y="6873840"/>
            <a:ext cx="260640" cy="258840"/>
          </a:xfrm>
          <a:prstGeom prst="ellipse">
            <a:avLst/>
          </a:prstGeom>
          <a:gradFill rotWithShape="0">
            <a:gsLst>
              <a:gs pos="0">
                <a:srgbClr val="ffa2a1"/>
              </a:gs>
              <a:gs pos="100000">
                <a:srgbClr val="ffe5e5"/>
              </a:gs>
            </a:gsLst>
            <a:lin ang="16200000"/>
          </a:gradFill>
          <a:ln w="9360">
            <a:solidFill>
              <a:srgbClr val="be4b48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feld 43"/>
          <p:cNvSpPr/>
          <p:nvPr/>
        </p:nvSpPr>
        <p:spPr>
          <a:xfrm>
            <a:off x="4181400" y="6948360"/>
            <a:ext cx="1038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acid phosphatase class 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Ellipse 45"/>
          <p:cNvSpPr/>
          <p:nvPr/>
        </p:nvSpPr>
        <p:spPr>
          <a:xfrm>
            <a:off x="2847960" y="5870520"/>
            <a:ext cx="258840" cy="25884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feld 46"/>
          <p:cNvSpPr/>
          <p:nvPr/>
        </p:nvSpPr>
        <p:spPr>
          <a:xfrm>
            <a:off x="2751120" y="5857920"/>
            <a:ext cx="52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PAD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Ellipse 48"/>
          <p:cNvSpPr/>
          <p:nvPr/>
        </p:nvSpPr>
        <p:spPr>
          <a:xfrm>
            <a:off x="4805280" y="5529240"/>
            <a:ext cx="260280" cy="25884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feld 49"/>
          <p:cNvSpPr/>
          <p:nvPr/>
        </p:nvSpPr>
        <p:spPr>
          <a:xfrm>
            <a:off x="4479840" y="5568840"/>
            <a:ext cx="1068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</a:rPr>
              <a:t>LEA protein_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Ellipse 51"/>
          <p:cNvSpPr/>
          <p:nvPr/>
        </p:nvSpPr>
        <p:spPr>
          <a:xfrm>
            <a:off x="3559320" y="6265800"/>
            <a:ext cx="260280" cy="25884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feld 52"/>
          <p:cNvSpPr/>
          <p:nvPr/>
        </p:nvSpPr>
        <p:spPr>
          <a:xfrm>
            <a:off x="3471840" y="6289560"/>
            <a:ext cx="60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XTR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Ellipse 54"/>
          <p:cNvSpPr/>
          <p:nvPr/>
        </p:nvSpPr>
        <p:spPr>
          <a:xfrm>
            <a:off x="5111640" y="5918040"/>
            <a:ext cx="258840" cy="258840"/>
          </a:xfrm>
          <a:prstGeom prst="ellipse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feld 55"/>
          <p:cNvSpPr/>
          <p:nvPr/>
        </p:nvSpPr>
        <p:spPr>
          <a:xfrm>
            <a:off x="5038560" y="5929200"/>
            <a:ext cx="66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GASA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Ellipse 57"/>
          <p:cNvSpPr/>
          <p:nvPr/>
        </p:nvSpPr>
        <p:spPr>
          <a:xfrm>
            <a:off x="3527280" y="5456160"/>
            <a:ext cx="258840" cy="258840"/>
          </a:xfrm>
          <a:prstGeom prst="ellipse">
            <a:avLst/>
          </a:prstGeom>
          <a:gradFill rotWithShape="0">
            <a:gsLst>
              <a:gs pos="0">
                <a:srgbClr val="ffa2a1"/>
              </a:gs>
              <a:gs pos="100000">
                <a:srgbClr val="ffe5e5"/>
              </a:gs>
            </a:gsLst>
            <a:lin ang="16200000"/>
          </a:gradFill>
          <a:ln w="9360">
            <a:solidFill>
              <a:srgbClr val="be4b48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Ellipse 60"/>
          <p:cNvSpPr/>
          <p:nvPr/>
        </p:nvSpPr>
        <p:spPr>
          <a:xfrm>
            <a:off x="4822920" y="6388200"/>
            <a:ext cx="258840" cy="258840"/>
          </a:xfrm>
          <a:prstGeom prst="ellipse">
            <a:avLst/>
          </a:prstGeom>
          <a:gradFill rotWithShape="0">
            <a:gsLst>
              <a:gs pos="0">
                <a:srgbClr val="ffa2a1"/>
              </a:gs>
              <a:gs pos="100000">
                <a:srgbClr val="ffe5e5"/>
              </a:gs>
            </a:gsLst>
            <a:lin ang="16200000"/>
          </a:gradFill>
          <a:ln w="9360">
            <a:solidFill>
              <a:srgbClr val="be4b48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feld 61"/>
          <p:cNvSpPr/>
          <p:nvPr/>
        </p:nvSpPr>
        <p:spPr>
          <a:xfrm>
            <a:off x="4300560" y="6335640"/>
            <a:ext cx="1295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protease inhibitor/seed storage/lipid transfer prote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Gerade Verbindung 112"/>
          <p:cNvSpPr/>
          <p:nvPr/>
        </p:nvSpPr>
        <p:spPr>
          <a:xfrm>
            <a:off x="2420280" y="5451480"/>
            <a:ext cx="199800" cy="26352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Gerade Verbindung 181"/>
          <p:cNvSpPr/>
          <p:nvPr/>
        </p:nvSpPr>
        <p:spPr>
          <a:xfrm>
            <a:off x="4935600" y="5788080"/>
            <a:ext cx="216000" cy="16812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Gerade Verbindung 99"/>
          <p:cNvSpPr/>
          <p:nvPr/>
        </p:nvSpPr>
        <p:spPr>
          <a:xfrm>
            <a:off x="3657600" y="5715000"/>
            <a:ext cx="31680" cy="55080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Gerade Verbindung 104"/>
          <p:cNvSpPr/>
          <p:nvPr/>
        </p:nvSpPr>
        <p:spPr>
          <a:xfrm flipV="1">
            <a:off x="3786120" y="5416560"/>
            <a:ext cx="362160" cy="16992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Gerade Verbindung 108"/>
          <p:cNvSpPr/>
          <p:nvPr/>
        </p:nvSpPr>
        <p:spPr>
          <a:xfrm>
            <a:off x="3786120" y="5586480"/>
            <a:ext cx="1019160" cy="7308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Gerade Verbindung 113"/>
          <p:cNvSpPr/>
          <p:nvPr/>
        </p:nvSpPr>
        <p:spPr>
          <a:xfrm>
            <a:off x="3749040" y="5676840"/>
            <a:ext cx="1361880" cy="37008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Gerade Verbindung 120"/>
          <p:cNvSpPr/>
          <p:nvPr/>
        </p:nvSpPr>
        <p:spPr>
          <a:xfrm flipH="1">
            <a:off x="4368600" y="5184720"/>
            <a:ext cx="330120" cy="14148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Gerade Verbindung 124"/>
          <p:cNvSpPr/>
          <p:nvPr/>
        </p:nvSpPr>
        <p:spPr>
          <a:xfrm>
            <a:off x="3749040" y="5676840"/>
            <a:ext cx="1111320" cy="74952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Gerade Verbindung 127"/>
          <p:cNvSpPr/>
          <p:nvPr/>
        </p:nvSpPr>
        <p:spPr>
          <a:xfrm>
            <a:off x="3749040" y="5676840"/>
            <a:ext cx="819000" cy="123372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Gerade Verbindung 142"/>
          <p:cNvSpPr/>
          <p:nvPr/>
        </p:nvSpPr>
        <p:spPr>
          <a:xfrm>
            <a:off x="2459160" y="5359320"/>
            <a:ext cx="355320" cy="19224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Gerade Verbindung 147"/>
          <p:cNvSpPr/>
          <p:nvPr/>
        </p:nvSpPr>
        <p:spPr>
          <a:xfrm flipH="1">
            <a:off x="1936800" y="5451480"/>
            <a:ext cx="301680" cy="16524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Gerade Verbindung 151"/>
          <p:cNvSpPr/>
          <p:nvPr/>
        </p:nvSpPr>
        <p:spPr>
          <a:xfrm>
            <a:off x="2329560" y="5487840"/>
            <a:ext cx="32040" cy="113220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Gerade Verbindung 155"/>
          <p:cNvSpPr/>
          <p:nvPr/>
        </p:nvSpPr>
        <p:spPr>
          <a:xfrm flipH="1">
            <a:off x="2453760" y="5676840"/>
            <a:ext cx="1111320" cy="98100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Gerade Verbindung 162"/>
          <p:cNvSpPr/>
          <p:nvPr/>
        </p:nvSpPr>
        <p:spPr>
          <a:xfrm flipH="1">
            <a:off x="2453760" y="5973840"/>
            <a:ext cx="166680" cy="68400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Gerade Verbindung 165"/>
          <p:cNvSpPr/>
          <p:nvPr/>
        </p:nvSpPr>
        <p:spPr>
          <a:xfrm flipH="1" flipV="1">
            <a:off x="1936800" y="6480000"/>
            <a:ext cx="333360" cy="17784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Gerade Verbindung 169"/>
          <p:cNvSpPr/>
          <p:nvPr/>
        </p:nvSpPr>
        <p:spPr>
          <a:xfrm flipH="1">
            <a:off x="1876320" y="6840360"/>
            <a:ext cx="393840" cy="35244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Gerade Verbindung 172"/>
          <p:cNvSpPr/>
          <p:nvPr/>
        </p:nvSpPr>
        <p:spPr>
          <a:xfrm>
            <a:off x="2453400" y="6840360"/>
            <a:ext cx="295560" cy="35748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Gerade Verbindung 176"/>
          <p:cNvSpPr/>
          <p:nvPr/>
        </p:nvSpPr>
        <p:spPr>
          <a:xfrm flipV="1">
            <a:off x="2454120" y="6091200"/>
            <a:ext cx="432000" cy="566640"/>
          </a:xfrm>
          <a:prstGeom prst="line">
            <a:avLst/>
          </a:prstGeom>
          <a:ln w="1908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Gerade Verbindung 183"/>
          <p:cNvSpPr/>
          <p:nvPr/>
        </p:nvSpPr>
        <p:spPr>
          <a:xfrm flipH="1">
            <a:off x="1941120" y="5586480"/>
            <a:ext cx="1585800" cy="70488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Gerade Verbindung 189"/>
          <p:cNvSpPr/>
          <p:nvPr/>
        </p:nvSpPr>
        <p:spPr>
          <a:xfrm flipH="1">
            <a:off x="3068640" y="5643720"/>
            <a:ext cx="458640" cy="26496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Gerade Verbindung 194"/>
          <p:cNvSpPr/>
          <p:nvPr/>
        </p:nvSpPr>
        <p:spPr>
          <a:xfrm flipV="1">
            <a:off x="2712960" y="5641560"/>
            <a:ext cx="139680" cy="11124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Gerade Verbindung 198"/>
          <p:cNvSpPr/>
          <p:nvPr/>
        </p:nvSpPr>
        <p:spPr>
          <a:xfrm flipH="1" flipV="1">
            <a:off x="1973160" y="5708520"/>
            <a:ext cx="557280" cy="4464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Gerade Verbindung 202"/>
          <p:cNvSpPr/>
          <p:nvPr/>
        </p:nvSpPr>
        <p:spPr>
          <a:xfrm flipH="1">
            <a:off x="1936440" y="5935680"/>
            <a:ext cx="593640" cy="36180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Gerade Verbindung 207"/>
          <p:cNvSpPr/>
          <p:nvPr/>
        </p:nvSpPr>
        <p:spPr>
          <a:xfrm>
            <a:off x="2751120" y="5845320"/>
            <a:ext cx="135000" cy="6336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Gerade Verbindung 210"/>
          <p:cNvSpPr/>
          <p:nvPr/>
        </p:nvSpPr>
        <p:spPr>
          <a:xfrm flipH="1">
            <a:off x="1936800" y="5451480"/>
            <a:ext cx="301680" cy="84600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Gerade Verbindung 213"/>
          <p:cNvSpPr/>
          <p:nvPr/>
        </p:nvSpPr>
        <p:spPr>
          <a:xfrm flipH="1">
            <a:off x="1936440" y="5487840"/>
            <a:ext cx="393480" cy="80964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Gerade Verbindung 217"/>
          <p:cNvSpPr/>
          <p:nvPr/>
        </p:nvSpPr>
        <p:spPr>
          <a:xfrm flipH="1">
            <a:off x="1973160" y="5998320"/>
            <a:ext cx="874800" cy="38916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Gerade Verbindung 220"/>
          <p:cNvSpPr/>
          <p:nvPr/>
        </p:nvSpPr>
        <p:spPr>
          <a:xfrm flipH="1" flipV="1">
            <a:off x="1973160" y="6387840"/>
            <a:ext cx="1586160" cy="612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Gerade Verbindung 223"/>
          <p:cNvSpPr/>
          <p:nvPr/>
        </p:nvSpPr>
        <p:spPr>
          <a:xfrm flipH="1" flipV="1">
            <a:off x="1844640" y="6516360"/>
            <a:ext cx="812880" cy="71748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Gerade Verbindung 226"/>
          <p:cNvSpPr/>
          <p:nvPr/>
        </p:nvSpPr>
        <p:spPr>
          <a:xfrm flipH="1" flipV="1">
            <a:off x="3068280" y="6090840"/>
            <a:ext cx="530280" cy="21276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Gerade Verbindung 229"/>
          <p:cNvSpPr/>
          <p:nvPr/>
        </p:nvSpPr>
        <p:spPr>
          <a:xfrm flipH="1">
            <a:off x="2492280" y="6486480"/>
            <a:ext cx="1106640" cy="263520"/>
          </a:xfrm>
          <a:prstGeom prst="line">
            <a:avLst/>
          </a:prstGeom>
          <a:ln w="93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Ellipse 60"/>
          <p:cNvSpPr/>
          <p:nvPr/>
        </p:nvSpPr>
        <p:spPr>
          <a:xfrm>
            <a:off x="4406760" y="3635280"/>
            <a:ext cx="257400" cy="258840"/>
          </a:xfrm>
          <a:prstGeom prst="ellipse">
            <a:avLst/>
          </a:prstGeom>
          <a:gradFill rotWithShape="0">
            <a:gsLst>
              <a:gs pos="0">
                <a:srgbClr val="ffa2a1"/>
              </a:gs>
              <a:gs pos="100000">
                <a:srgbClr val="ffe5e5"/>
              </a:gs>
            </a:gsLst>
            <a:lin ang="16200000"/>
          </a:gradFill>
          <a:ln w="9360">
            <a:solidFill>
              <a:srgbClr val="be4b48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feld 61"/>
          <p:cNvSpPr/>
          <p:nvPr/>
        </p:nvSpPr>
        <p:spPr>
          <a:xfrm>
            <a:off x="3936960" y="3589200"/>
            <a:ext cx="1224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protease inhibitor/seed storage/lipid transfer prote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feld 58"/>
          <p:cNvSpPr/>
          <p:nvPr/>
        </p:nvSpPr>
        <p:spPr>
          <a:xfrm>
            <a:off x="3359160" y="5448240"/>
            <a:ext cx="690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TPRP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feld 41"/>
          <p:cNvSpPr/>
          <p:nvPr/>
        </p:nvSpPr>
        <p:spPr>
          <a:xfrm>
            <a:off x="3614760" y="2338560"/>
            <a:ext cx="746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unknown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 Box 180"/>
          <p:cNvSpPr/>
          <p:nvPr/>
        </p:nvSpPr>
        <p:spPr>
          <a:xfrm>
            <a:off x="1598760" y="1116000"/>
            <a:ext cx="122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WT se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 Box 181"/>
          <p:cNvSpPr/>
          <p:nvPr/>
        </p:nvSpPr>
        <p:spPr>
          <a:xfrm>
            <a:off x="1022400" y="4435560"/>
            <a:ext cx="23763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DE" sz="1800" spc="-1" strike="noStrike">
                <a:solidFill>
                  <a:srgbClr val="000000"/>
                </a:solidFill>
                <a:latin typeface="Arial"/>
              </a:rPr>
              <a:t>AtHb1</a:t>
            </a: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- overexpressing se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feld 37"/>
          <p:cNvSpPr/>
          <p:nvPr/>
        </p:nvSpPr>
        <p:spPr>
          <a:xfrm>
            <a:off x="4408560" y="4992840"/>
            <a:ext cx="1068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oxidoreduct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feld 10"/>
          <p:cNvSpPr/>
          <p:nvPr/>
        </p:nvSpPr>
        <p:spPr>
          <a:xfrm>
            <a:off x="2077920" y="5181480"/>
            <a:ext cx="72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FLA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feld 12"/>
          <p:cNvSpPr/>
          <p:nvPr/>
        </p:nvSpPr>
        <p:spPr>
          <a:xfrm>
            <a:off x="1311120" y="6145200"/>
            <a:ext cx="1159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</a:rPr>
              <a:t>S-adenosyl-L-methionine:carboxyl methyltransferase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feld 10"/>
          <p:cNvSpPr/>
          <p:nvPr/>
        </p:nvSpPr>
        <p:spPr>
          <a:xfrm>
            <a:off x="3327480" y="1546200"/>
            <a:ext cx="853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FLA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2895480" y="2482560"/>
            <a:ext cx="100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mid-chain alkane hydroxylase 1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2176560" y="5641560"/>
            <a:ext cx="1008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mid-chain alkane hydroxylase 1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feld 22"/>
          <p:cNvSpPr/>
          <p:nvPr/>
        </p:nvSpPr>
        <p:spPr>
          <a:xfrm>
            <a:off x="1219320" y="5522760"/>
            <a:ext cx="1224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xyloglucan:xyloglucosyl transferase 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feld 20"/>
          <p:cNvSpPr/>
          <p:nvPr/>
        </p:nvSpPr>
        <p:spPr>
          <a:xfrm>
            <a:off x="2463840" y="5208480"/>
            <a:ext cx="1008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xyloglucan:xyloglucosyl transferase B / XTR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8-06T10:45:14Z</dcterms:created>
  <dc:creator>rollet</dc:creator>
  <dc:description/>
  <dc:language>en-US</dc:language>
  <cp:lastModifiedBy>ITB</cp:lastModifiedBy>
  <dcterms:modified xsi:type="dcterms:W3CDTF">2011-03-07T15:57:26Z</dcterms:modified>
  <cp:revision>10</cp:revision>
  <dc:subject/>
  <dc:title>Folie 1</dc:title>
</cp:coreProperties>
</file>